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2563" y="-365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00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845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26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944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4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695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991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695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466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007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117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8D4DE-3205-4670-97F7-136CFE0A848C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D5E42-075C-4C82-B538-486CA731B1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912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8743" y="57149"/>
            <a:ext cx="1222820" cy="13675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8743" y="1554123"/>
            <a:ext cx="1236821" cy="13675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62" y="57149"/>
            <a:ext cx="1253729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476" y="57149"/>
            <a:ext cx="1216581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9075" y="57149"/>
            <a:ext cx="2001322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293" y="1554123"/>
            <a:ext cx="1230511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3194" y="1554123"/>
            <a:ext cx="1188720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7650" y="1554123"/>
            <a:ext cx="1764506" cy="136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55486" y="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667476" y="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048363" y="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57150" y="1495545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669140" y="1495545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050027" y="1495545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0" y="6457951"/>
            <a:ext cx="685800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hanges in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ampestero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a/e)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sitostero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b/f)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lanostero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c/g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holesterol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d/h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esmosterol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m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achidonic aci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j/n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romboxane B2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k/o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prostaglandin D2 </a:t>
            </a:r>
            <a:r>
              <a:rPr lang="en-US" sz="900" smtClean="0">
                <a:latin typeface="Arial" panose="020B0604020202020204" pitchFamily="34" charset="0"/>
                <a:cs typeface="Arial" panose="020B0604020202020204" pitchFamily="34" charset="0"/>
              </a:rPr>
              <a:t>(l/p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f the brain structures cortex, hippocampus, hypothalamus and cerebellum, liver and plasma from mal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/+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ice fed a standard chow diet. Different colors of the bar segments indicate the concentration of each structure/matrix separately. All concentrations were summed up to the total concentration, which is expressed by the bar height.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346285" y="1495545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355903" y="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3260884"/>
            <a:ext cx="1157288" cy="127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3022" y="3260884"/>
            <a:ext cx="1191578" cy="1255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7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4746784"/>
            <a:ext cx="1238726" cy="127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8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185" y="4746784"/>
            <a:ext cx="1491615" cy="127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9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0164" y="4746784"/>
            <a:ext cx="1204436" cy="1255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6226" y="3260884"/>
            <a:ext cx="1847374" cy="127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5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12" y="3260884"/>
            <a:ext cx="1157288" cy="1255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10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" y="4746784"/>
            <a:ext cx="1097280" cy="1255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" name="Textfeld 32"/>
          <p:cNvSpPr txBox="1"/>
          <p:nvPr/>
        </p:nvSpPr>
        <p:spPr>
          <a:xfrm>
            <a:off x="60316" y="3203733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355903" y="3203733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4069263" y="3203733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678758" y="3203733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60315" y="4689633"/>
            <a:ext cx="33855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327049" y="4689633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4059645" y="4689633"/>
            <a:ext cx="3000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669140" y="4689633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Gerader Verbinder 40"/>
          <p:cNvCxnSpPr/>
          <p:nvPr/>
        </p:nvCxnSpPr>
        <p:spPr>
          <a:xfrm>
            <a:off x="0" y="3048000"/>
            <a:ext cx="518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8422208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Bildschirmpräsentation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15</cp:revision>
  <cp:lastPrinted>2020-12-14T13:44:35Z</cp:lastPrinted>
  <dcterms:created xsi:type="dcterms:W3CDTF">2020-04-23T14:15:59Z</dcterms:created>
  <dcterms:modified xsi:type="dcterms:W3CDTF">2021-09-21T13:06:23Z</dcterms:modified>
</cp:coreProperties>
</file>